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99"/>
    <a:srgbClr val="00CC99"/>
    <a:srgbClr val="33CC33"/>
    <a:srgbClr val="9933FF"/>
    <a:srgbClr val="9966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4" autoAdjust="0"/>
    <p:restoredTop sz="94842" autoAdjust="0"/>
  </p:normalViewPr>
  <p:slideViewPr>
    <p:cSldViewPr snapToGrid="0">
      <p:cViewPr>
        <p:scale>
          <a:sx n="51" d="100"/>
          <a:sy n="51" d="100"/>
        </p:scale>
        <p:origin x="2478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浦　颯" userId="30eb12cf-a0f0-479c-babe-56a40fd49a1c" providerId="ADAL" clId="{CCF08334-B7FB-451B-84BC-3BE0F90B41AA}"/>
    <pc:docChg chg="undo custSel addSld delSld modSld">
      <pc:chgData name="西浦　颯" userId="30eb12cf-a0f0-479c-babe-56a40fd49a1c" providerId="ADAL" clId="{CCF08334-B7FB-451B-84BC-3BE0F90B41AA}" dt="2024-05-14T09:27:19.510" v="220" actId="164"/>
      <pc:docMkLst>
        <pc:docMk/>
      </pc:docMkLst>
      <pc:sldChg chg="modNotesTx">
        <pc:chgData name="西浦　颯" userId="30eb12cf-a0f0-479c-babe-56a40fd49a1c" providerId="ADAL" clId="{CCF08334-B7FB-451B-84BC-3BE0F90B41AA}" dt="2024-05-10T02:04:04.579" v="6" actId="20577"/>
        <pc:sldMkLst>
          <pc:docMk/>
          <pc:sldMk cId="2775093129" sldId="257"/>
        </pc:sldMkLst>
      </pc:sldChg>
      <pc:sldChg chg="addSp delSp modSp mod modNotesTx">
        <pc:chgData name="西浦　颯" userId="30eb12cf-a0f0-479c-babe-56a40fd49a1c" providerId="ADAL" clId="{CCF08334-B7FB-451B-84BC-3BE0F90B41AA}" dt="2024-05-10T08:44:00.124" v="182" actId="164"/>
        <pc:sldMkLst>
          <pc:docMk/>
          <pc:sldMk cId="1552739713" sldId="261"/>
        </pc:sldMkLst>
        <pc:spChg chg="mod topLvl">
          <ac:chgData name="西浦　颯" userId="30eb12cf-a0f0-479c-babe-56a40fd49a1c" providerId="ADAL" clId="{CCF08334-B7FB-451B-84BC-3BE0F90B41AA}" dt="2024-05-10T03:03:30.636" v="32" actId="164"/>
          <ac:spMkLst>
            <pc:docMk/>
            <pc:sldMk cId="1552739713" sldId="261"/>
            <ac:spMk id="13" creationId="{3B220B2E-1DB8-BBB3-5ABD-B81F369ACD3E}"/>
          </ac:spMkLst>
        </pc:spChg>
        <pc:spChg chg="mod topLvl">
          <ac:chgData name="西浦　颯" userId="30eb12cf-a0f0-479c-babe-56a40fd49a1c" providerId="ADAL" clId="{CCF08334-B7FB-451B-84BC-3BE0F90B41AA}" dt="2024-05-10T03:04:03.751" v="42" actId="164"/>
          <ac:spMkLst>
            <pc:docMk/>
            <pc:sldMk cId="1552739713" sldId="261"/>
            <ac:spMk id="14" creationId="{B08E8C56-3F9D-4393-B23F-8B9C44B87713}"/>
          </ac:spMkLst>
        </pc:spChg>
        <pc:spChg chg="mod topLvl">
          <ac:chgData name="西浦　颯" userId="30eb12cf-a0f0-479c-babe-56a40fd49a1c" providerId="ADAL" clId="{CCF08334-B7FB-451B-84BC-3BE0F90B41AA}" dt="2024-05-10T03:03:49.178" v="37" actId="164"/>
          <ac:spMkLst>
            <pc:docMk/>
            <pc:sldMk cId="1552739713" sldId="261"/>
            <ac:spMk id="15" creationId="{8BE1F01D-5651-4778-EEB5-BDD65FEF6C43}"/>
          </ac:spMkLst>
        </pc:spChg>
        <pc:spChg chg="mod topLvl">
          <ac:chgData name="西浦　颯" userId="30eb12cf-a0f0-479c-babe-56a40fd49a1c" providerId="ADAL" clId="{CCF08334-B7FB-451B-84BC-3BE0F90B41AA}" dt="2024-05-10T03:03:38.135" v="33" actId="164"/>
          <ac:spMkLst>
            <pc:docMk/>
            <pc:sldMk cId="1552739713" sldId="261"/>
            <ac:spMk id="16" creationId="{4F2DEAFC-022A-B9FA-94A5-DB950B5E5B41}"/>
          </ac:spMkLst>
        </pc:spChg>
        <pc:spChg chg="mod topLvl">
          <ac:chgData name="西浦　颯" userId="30eb12cf-a0f0-479c-babe-56a40fd49a1c" providerId="ADAL" clId="{CCF08334-B7FB-451B-84BC-3BE0F90B41AA}" dt="2024-05-10T03:03:30.636" v="32" actId="164"/>
          <ac:spMkLst>
            <pc:docMk/>
            <pc:sldMk cId="1552739713" sldId="261"/>
            <ac:spMk id="17" creationId="{490DE562-0F5C-4406-6BBF-5E49EDB541F8}"/>
          </ac:spMkLst>
        </pc:spChg>
        <pc:spChg chg="mod topLvl">
          <ac:chgData name="西浦　颯" userId="30eb12cf-a0f0-479c-babe-56a40fd49a1c" providerId="ADAL" clId="{CCF08334-B7FB-451B-84BC-3BE0F90B41AA}" dt="2024-05-10T03:04:03.751" v="42" actId="164"/>
          <ac:spMkLst>
            <pc:docMk/>
            <pc:sldMk cId="1552739713" sldId="261"/>
            <ac:spMk id="18" creationId="{BF6AF18F-F389-9426-B82E-EE0ACA58B71C}"/>
          </ac:spMkLst>
        </pc:spChg>
        <pc:spChg chg="mod topLvl">
          <ac:chgData name="西浦　颯" userId="30eb12cf-a0f0-479c-babe-56a40fd49a1c" providerId="ADAL" clId="{CCF08334-B7FB-451B-84BC-3BE0F90B41AA}" dt="2024-05-10T03:03:49.178" v="37" actId="164"/>
          <ac:spMkLst>
            <pc:docMk/>
            <pc:sldMk cId="1552739713" sldId="261"/>
            <ac:spMk id="19" creationId="{353F3ADD-9883-7C60-62CB-0EE6E415AED3}"/>
          </ac:spMkLst>
        </pc:spChg>
        <pc:spChg chg="mod topLvl">
          <ac:chgData name="西浦　颯" userId="30eb12cf-a0f0-479c-babe-56a40fd49a1c" providerId="ADAL" clId="{CCF08334-B7FB-451B-84BC-3BE0F90B41AA}" dt="2024-05-10T03:03:38.135" v="33" actId="164"/>
          <ac:spMkLst>
            <pc:docMk/>
            <pc:sldMk cId="1552739713" sldId="261"/>
            <ac:spMk id="20" creationId="{9DC5AB7D-65A0-58C5-B05F-2449DAFC8CBD}"/>
          </ac:spMkLst>
        </pc:spChg>
        <pc:spChg chg="mod topLvl">
          <ac:chgData name="西浦　颯" userId="30eb12cf-a0f0-479c-babe-56a40fd49a1c" providerId="ADAL" clId="{CCF08334-B7FB-451B-84BC-3BE0F90B41AA}" dt="2024-05-10T03:03:30.636" v="32" actId="164"/>
          <ac:spMkLst>
            <pc:docMk/>
            <pc:sldMk cId="1552739713" sldId="261"/>
            <ac:spMk id="21" creationId="{E6748492-F0C4-33AB-FD92-D8655D606160}"/>
          </ac:spMkLst>
        </pc:spChg>
        <pc:spChg chg="mod topLvl">
          <ac:chgData name="西浦　颯" userId="30eb12cf-a0f0-479c-babe-56a40fd49a1c" providerId="ADAL" clId="{CCF08334-B7FB-451B-84BC-3BE0F90B41AA}" dt="2024-05-10T03:04:03.751" v="42" actId="164"/>
          <ac:spMkLst>
            <pc:docMk/>
            <pc:sldMk cId="1552739713" sldId="261"/>
            <ac:spMk id="22" creationId="{E7FEF51F-2F6D-9A20-009B-B627EB51B003}"/>
          </ac:spMkLst>
        </pc:spChg>
        <pc:spChg chg="mod topLvl">
          <ac:chgData name="西浦　颯" userId="30eb12cf-a0f0-479c-babe-56a40fd49a1c" providerId="ADAL" clId="{CCF08334-B7FB-451B-84BC-3BE0F90B41AA}" dt="2024-05-10T03:03:49.178" v="37" actId="164"/>
          <ac:spMkLst>
            <pc:docMk/>
            <pc:sldMk cId="1552739713" sldId="261"/>
            <ac:spMk id="23" creationId="{82BE41C2-B16F-9BFE-4101-18A2F104D91A}"/>
          </ac:spMkLst>
        </pc:spChg>
        <pc:spChg chg="mod topLvl">
          <ac:chgData name="西浦　颯" userId="30eb12cf-a0f0-479c-babe-56a40fd49a1c" providerId="ADAL" clId="{CCF08334-B7FB-451B-84BC-3BE0F90B41AA}" dt="2024-05-10T03:03:38.135" v="33" actId="164"/>
          <ac:spMkLst>
            <pc:docMk/>
            <pc:sldMk cId="1552739713" sldId="261"/>
            <ac:spMk id="24" creationId="{297A7111-DAE6-D4F7-D343-D783C62B673B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25" creationId="{9AA670C2-9428-C00F-09F6-D9EF284B3717}"/>
          </ac:spMkLst>
        </pc:spChg>
        <pc:spChg chg="mod topLvl">
          <ac:chgData name="西浦　颯" userId="30eb12cf-a0f0-479c-babe-56a40fd49a1c" providerId="ADAL" clId="{CCF08334-B7FB-451B-84BC-3BE0F90B41AA}" dt="2024-05-10T08:43:16.846" v="176" actId="20577"/>
          <ac:spMkLst>
            <pc:docMk/>
            <pc:sldMk cId="1552739713" sldId="261"/>
            <ac:spMk id="26" creationId="{06C266A2-8F3A-8F72-2CC4-79E4FBBFA857}"/>
          </ac:spMkLst>
        </pc:spChg>
        <pc:spChg chg="mod topLvl">
          <ac:chgData name="西浦　颯" userId="30eb12cf-a0f0-479c-babe-56a40fd49a1c" providerId="ADAL" clId="{CCF08334-B7FB-451B-84BC-3BE0F90B41AA}" dt="2024-05-10T03:04:03.751" v="42" actId="164"/>
          <ac:spMkLst>
            <pc:docMk/>
            <pc:sldMk cId="1552739713" sldId="261"/>
            <ac:spMk id="27" creationId="{E594BB18-F76A-A766-58B4-2446899F62D2}"/>
          </ac:spMkLst>
        </pc:spChg>
        <pc:spChg chg="mod topLvl">
          <ac:chgData name="西浦　颯" userId="30eb12cf-a0f0-479c-babe-56a40fd49a1c" providerId="ADAL" clId="{CCF08334-B7FB-451B-84BC-3BE0F90B41AA}" dt="2024-05-10T03:03:49.178" v="37" actId="164"/>
          <ac:spMkLst>
            <pc:docMk/>
            <pc:sldMk cId="1552739713" sldId="261"/>
            <ac:spMk id="28" creationId="{1AAF0162-39BB-85A5-7633-2AC6DA0717B2}"/>
          </ac:spMkLst>
        </pc:spChg>
        <pc:spChg chg="mod topLvl">
          <ac:chgData name="西浦　颯" userId="30eb12cf-a0f0-479c-babe-56a40fd49a1c" providerId="ADAL" clId="{CCF08334-B7FB-451B-84BC-3BE0F90B41AA}" dt="2024-05-10T08:43:11.951" v="174" actId="20577"/>
          <ac:spMkLst>
            <pc:docMk/>
            <pc:sldMk cId="1552739713" sldId="261"/>
            <ac:spMk id="29" creationId="{C29DC909-417C-4067-CDBD-621FCE805DE5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30" creationId="{09A0C8C0-5096-CB7C-2204-09841F85CE43}"/>
          </ac:spMkLst>
        </pc:spChg>
        <pc:spChg chg="add del mod">
          <ac:chgData name="西浦　颯" userId="30eb12cf-a0f0-479c-babe-56a40fd49a1c" providerId="ADAL" clId="{CCF08334-B7FB-451B-84BC-3BE0F90B41AA}" dt="2024-05-10T03:07:57.820" v="143" actId="478"/>
          <ac:spMkLst>
            <pc:docMk/>
            <pc:sldMk cId="1552739713" sldId="261"/>
            <ac:spMk id="31" creationId="{EC324D87-0788-0FB5-E05B-50B725B3755B}"/>
          </ac:spMkLst>
        </pc:spChg>
        <pc:spChg chg="add mod ord">
          <ac:chgData name="西浦　颯" userId="30eb12cf-a0f0-479c-babe-56a40fd49a1c" providerId="ADAL" clId="{CCF08334-B7FB-451B-84BC-3BE0F90B41AA}" dt="2024-05-10T08:44:00.124" v="182" actId="164"/>
          <ac:spMkLst>
            <pc:docMk/>
            <pc:sldMk cId="1552739713" sldId="261"/>
            <ac:spMk id="34" creationId="{7F437699-62CA-9AB6-17FD-A50DBEE953B3}"/>
          </ac:spMkLst>
        </pc:spChg>
        <pc:spChg chg="mod topLvl">
          <ac:chgData name="西浦　颯" userId="30eb12cf-a0f0-479c-babe-56a40fd49a1c" providerId="ADAL" clId="{CCF08334-B7FB-451B-84BC-3BE0F90B41AA}" dt="2024-05-10T03:03:49.178" v="37" actId="164"/>
          <ac:spMkLst>
            <pc:docMk/>
            <pc:sldMk cId="1552739713" sldId="261"/>
            <ac:spMk id="35" creationId="{001A2B6A-129E-16AE-5165-ED09E6BC819B}"/>
          </ac:spMkLst>
        </pc:spChg>
        <pc:spChg chg="mod topLvl">
          <ac:chgData name="西浦　颯" userId="30eb12cf-a0f0-479c-babe-56a40fd49a1c" providerId="ADAL" clId="{CCF08334-B7FB-451B-84BC-3BE0F90B41AA}" dt="2024-05-10T03:03:30.636" v="32" actId="164"/>
          <ac:spMkLst>
            <pc:docMk/>
            <pc:sldMk cId="1552739713" sldId="261"/>
            <ac:spMk id="36" creationId="{F5D8FCF7-A171-5121-1D00-C6906352BA9C}"/>
          </ac:spMkLst>
        </pc:spChg>
        <pc:spChg chg="mod topLvl">
          <ac:chgData name="西浦　颯" userId="30eb12cf-a0f0-479c-babe-56a40fd49a1c" providerId="ADAL" clId="{CCF08334-B7FB-451B-84BC-3BE0F90B41AA}" dt="2024-05-10T03:03:38.135" v="33" actId="164"/>
          <ac:spMkLst>
            <pc:docMk/>
            <pc:sldMk cId="1552739713" sldId="261"/>
            <ac:spMk id="37" creationId="{04068F84-AA89-0429-2ED9-0AD43927A68C}"/>
          </ac:spMkLst>
        </pc:spChg>
        <pc:spChg chg="mod topLvl">
          <ac:chgData name="西浦　颯" userId="30eb12cf-a0f0-479c-babe-56a40fd49a1c" providerId="ADAL" clId="{CCF08334-B7FB-451B-84BC-3BE0F90B41AA}" dt="2024-05-10T03:04:03.751" v="42" actId="164"/>
          <ac:spMkLst>
            <pc:docMk/>
            <pc:sldMk cId="1552739713" sldId="261"/>
            <ac:spMk id="38" creationId="{16E26396-81AC-FA0F-C7DE-395DE31ABBAD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39" creationId="{E2CE1392-6A27-15F4-CD28-35AE392F46BC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40" creationId="{C10C29E9-48CE-FF43-5B2E-FA85F280AFE1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41" creationId="{D483B6C4-79F5-6709-6FE0-81ECFF3636E7}"/>
          </ac:spMkLst>
        </pc:spChg>
        <pc:spChg chg="mod topLvl">
          <ac:chgData name="西浦　颯" userId="30eb12cf-a0f0-479c-babe-56a40fd49a1c" providerId="ADAL" clId="{CCF08334-B7FB-451B-84BC-3BE0F90B41AA}" dt="2024-05-10T04:26:11.971" v="172" actId="164"/>
          <ac:spMkLst>
            <pc:docMk/>
            <pc:sldMk cId="1552739713" sldId="261"/>
            <ac:spMk id="42" creationId="{F0566FE3-22B5-6262-0E94-8DF37D76458A}"/>
          </ac:spMkLst>
        </pc:spChg>
        <pc:grpChg chg="add del mod">
          <ac:chgData name="西浦　颯" userId="30eb12cf-a0f0-479c-babe-56a40fd49a1c" providerId="ADAL" clId="{CCF08334-B7FB-451B-84BC-3BE0F90B41AA}" dt="2024-05-10T03:03:06.129" v="26" actId="165"/>
          <ac:grpSpMkLst>
            <pc:docMk/>
            <pc:sldMk cId="1552739713" sldId="261"/>
            <ac:grpSpMk id="2" creationId="{C24BC66B-60DF-E8CC-72F4-0D6E6701A679}"/>
          </ac:grpSpMkLst>
        </pc:grpChg>
        <pc:grpChg chg="add mod">
          <ac:chgData name="西浦　颯" userId="30eb12cf-a0f0-479c-babe-56a40fd49a1c" providerId="ADAL" clId="{CCF08334-B7FB-451B-84BC-3BE0F90B41AA}" dt="2024-05-10T03:03:17.579" v="30" actId="164"/>
          <ac:grpSpMkLst>
            <pc:docMk/>
            <pc:sldMk cId="1552739713" sldId="261"/>
            <ac:grpSpMk id="4" creationId="{3E74FF11-251B-8CCF-7502-ABFD185A9D1D}"/>
          </ac:grpSpMkLst>
        </pc:grpChg>
        <pc:grpChg chg="add mod">
          <ac:chgData name="西浦　颯" userId="30eb12cf-a0f0-479c-babe-56a40fd49a1c" providerId="ADAL" clId="{CCF08334-B7FB-451B-84BC-3BE0F90B41AA}" dt="2024-05-10T04:26:11.971" v="172" actId="164"/>
          <ac:grpSpMkLst>
            <pc:docMk/>
            <pc:sldMk cId="1552739713" sldId="261"/>
            <ac:grpSpMk id="6" creationId="{699C885B-82D9-64AC-93DA-6DC0034C8FDC}"/>
          </ac:grpSpMkLst>
        </pc:grpChg>
        <pc:grpChg chg="add mod">
          <ac:chgData name="西浦　颯" userId="30eb12cf-a0f0-479c-babe-56a40fd49a1c" providerId="ADAL" clId="{CCF08334-B7FB-451B-84BC-3BE0F90B41AA}" dt="2024-05-10T04:26:11.971" v="172" actId="164"/>
          <ac:grpSpMkLst>
            <pc:docMk/>
            <pc:sldMk cId="1552739713" sldId="261"/>
            <ac:grpSpMk id="8" creationId="{C40AC4E9-0AA3-DECD-7D71-4655EDDDB484}"/>
          </ac:grpSpMkLst>
        </pc:grpChg>
        <pc:grpChg chg="add mod">
          <ac:chgData name="西浦　颯" userId="30eb12cf-a0f0-479c-babe-56a40fd49a1c" providerId="ADAL" clId="{CCF08334-B7FB-451B-84BC-3BE0F90B41AA}" dt="2024-05-10T04:26:11.971" v="172" actId="164"/>
          <ac:grpSpMkLst>
            <pc:docMk/>
            <pc:sldMk cId="1552739713" sldId="261"/>
            <ac:grpSpMk id="11" creationId="{3DD204B0-9932-0364-D8DD-32B6F15424BB}"/>
          </ac:grpSpMkLst>
        </pc:grpChg>
        <pc:grpChg chg="add mod">
          <ac:chgData name="西浦　颯" userId="30eb12cf-a0f0-479c-babe-56a40fd49a1c" providerId="ADAL" clId="{CCF08334-B7FB-451B-84BC-3BE0F90B41AA}" dt="2024-05-10T04:26:11.971" v="172" actId="164"/>
          <ac:grpSpMkLst>
            <pc:docMk/>
            <pc:sldMk cId="1552739713" sldId="261"/>
            <ac:grpSpMk id="12" creationId="{CA9B823E-BD3C-E18B-ADE3-931B9E5286CE}"/>
          </ac:grpSpMkLst>
        </pc:grpChg>
        <pc:grpChg chg="add mod">
          <ac:chgData name="西浦　颯" userId="30eb12cf-a0f0-479c-babe-56a40fd49a1c" providerId="ADAL" clId="{CCF08334-B7FB-451B-84BC-3BE0F90B41AA}" dt="2024-05-10T08:44:00.124" v="182" actId="164"/>
          <ac:grpSpMkLst>
            <pc:docMk/>
            <pc:sldMk cId="1552739713" sldId="261"/>
            <ac:grpSpMk id="32" creationId="{B36D1D43-FA4D-BF59-7212-5E35540FD3D6}"/>
          </ac:grpSpMkLst>
        </pc:grpChg>
        <pc:grpChg chg="del mod topLvl">
          <ac:chgData name="西浦　颯" userId="30eb12cf-a0f0-479c-babe-56a40fd49a1c" providerId="ADAL" clId="{CCF08334-B7FB-451B-84BC-3BE0F90B41AA}" dt="2024-05-10T03:03:25.183" v="31" actId="165"/>
          <ac:grpSpMkLst>
            <pc:docMk/>
            <pc:sldMk cId="1552739713" sldId="261"/>
            <ac:grpSpMk id="33" creationId="{8A48A450-9B91-6735-4D9C-5C85720BCED0}"/>
          </ac:grpSpMkLst>
        </pc:grpChg>
        <pc:grpChg chg="add mod">
          <ac:chgData name="西浦　颯" userId="30eb12cf-a0f0-479c-babe-56a40fd49a1c" providerId="ADAL" clId="{CCF08334-B7FB-451B-84BC-3BE0F90B41AA}" dt="2024-05-10T08:44:00.124" v="182" actId="164"/>
          <ac:grpSpMkLst>
            <pc:docMk/>
            <pc:sldMk cId="1552739713" sldId="261"/>
            <ac:grpSpMk id="43" creationId="{38C4F72A-6FCC-A9AC-641A-A6B25D388FF5}"/>
          </ac:grpSpMkLst>
        </pc:grpChg>
        <pc:picChg chg="mod topLvl">
          <ac:chgData name="西浦　颯" userId="30eb12cf-a0f0-479c-babe-56a40fd49a1c" providerId="ADAL" clId="{CCF08334-B7FB-451B-84BC-3BE0F90B41AA}" dt="2024-05-10T03:03:38.135" v="33" actId="164"/>
          <ac:picMkLst>
            <pc:docMk/>
            <pc:sldMk cId="1552739713" sldId="261"/>
            <ac:picMk id="3" creationId="{99841E0C-AE42-6A2E-51B1-567D48944799}"/>
          </ac:picMkLst>
        </pc:picChg>
        <pc:picChg chg="mod topLvl">
          <ac:chgData name="西浦　颯" userId="30eb12cf-a0f0-479c-babe-56a40fd49a1c" providerId="ADAL" clId="{CCF08334-B7FB-451B-84BC-3BE0F90B41AA}" dt="2024-05-10T03:04:03.751" v="42" actId="164"/>
          <ac:picMkLst>
            <pc:docMk/>
            <pc:sldMk cId="1552739713" sldId="261"/>
            <ac:picMk id="5" creationId="{4ABFB457-6168-CB07-1D49-A48D440C8673}"/>
          </ac:picMkLst>
        </pc:picChg>
        <pc:picChg chg="mod topLvl">
          <ac:chgData name="西浦　颯" userId="30eb12cf-a0f0-479c-babe-56a40fd49a1c" providerId="ADAL" clId="{CCF08334-B7FB-451B-84BC-3BE0F90B41AA}" dt="2024-05-10T03:03:49.178" v="37" actId="164"/>
          <ac:picMkLst>
            <pc:docMk/>
            <pc:sldMk cId="1552739713" sldId="261"/>
            <ac:picMk id="7" creationId="{4DB7AD4D-1C2E-5B24-FDA6-EECD9E0B5827}"/>
          </ac:picMkLst>
        </pc:picChg>
        <pc:picChg chg="mod topLvl">
          <ac:chgData name="西浦　颯" userId="30eb12cf-a0f0-479c-babe-56a40fd49a1c" providerId="ADAL" clId="{CCF08334-B7FB-451B-84BC-3BE0F90B41AA}" dt="2024-05-10T03:03:30.636" v="32" actId="164"/>
          <ac:picMkLst>
            <pc:docMk/>
            <pc:sldMk cId="1552739713" sldId="261"/>
            <ac:picMk id="9" creationId="{9E6A3733-A9D1-7401-17EF-DE900F2577DF}"/>
          </ac:picMkLst>
        </pc:picChg>
        <pc:picChg chg="mod topLvl">
          <ac:chgData name="西浦　颯" userId="30eb12cf-a0f0-479c-babe-56a40fd49a1c" providerId="ADAL" clId="{CCF08334-B7FB-451B-84BC-3BE0F90B41AA}" dt="2024-05-10T04:26:11.971" v="172" actId="164"/>
          <ac:picMkLst>
            <pc:docMk/>
            <pc:sldMk cId="1552739713" sldId="261"/>
            <ac:picMk id="10" creationId="{84A143FD-BA8F-63F8-FA68-B967187D6F58}"/>
          </ac:picMkLst>
        </pc:picChg>
      </pc:sldChg>
      <pc:sldChg chg="modSp">
        <pc:chgData name="西浦　颯" userId="30eb12cf-a0f0-479c-babe-56a40fd49a1c" providerId="ADAL" clId="{CCF08334-B7FB-451B-84BC-3BE0F90B41AA}" dt="2024-05-10T01:19:22.016" v="1" actId="20578"/>
        <pc:sldMkLst>
          <pc:docMk/>
          <pc:sldMk cId="304154118" sldId="262"/>
        </pc:sldMkLst>
        <pc:spChg chg="mod">
          <ac:chgData name="西浦　颯" userId="30eb12cf-a0f0-479c-babe-56a40fd49a1c" providerId="ADAL" clId="{CCF08334-B7FB-451B-84BC-3BE0F90B41AA}" dt="2024-05-10T01:19:22.016" v="1" actId="20578"/>
          <ac:spMkLst>
            <pc:docMk/>
            <pc:sldMk cId="304154118" sldId="262"/>
            <ac:spMk id="7" creationId="{BA6C9A95-3162-6ABB-33D4-EA6651FE083F}"/>
          </ac:spMkLst>
        </pc:spChg>
      </pc:sldChg>
      <pc:sldChg chg="addSp modSp mod modNotesTx">
        <pc:chgData name="西浦　颯" userId="30eb12cf-a0f0-479c-babe-56a40fd49a1c" providerId="ADAL" clId="{CCF08334-B7FB-451B-84BC-3BE0F90B41AA}" dt="2024-05-14T09:27:19.510" v="220" actId="164"/>
        <pc:sldMkLst>
          <pc:docMk/>
          <pc:sldMk cId="2570755398" sldId="264"/>
        </pc:sldMkLst>
        <pc:spChg chg="add mod">
          <ac:chgData name="西浦　颯" userId="30eb12cf-a0f0-479c-babe-56a40fd49a1c" providerId="ADAL" clId="{CCF08334-B7FB-451B-84BC-3BE0F90B41AA}" dt="2024-05-14T09:27:19.510" v="220" actId="164"/>
          <ac:spMkLst>
            <pc:docMk/>
            <pc:sldMk cId="2570755398" sldId="264"/>
            <ac:spMk id="3" creationId="{4D7BC668-763B-CC80-6149-0854F78BD3DA}"/>
          </ac:spMkLst>
        </pc:spChg>
        <pc:spChg chg="add mod">
          <ac:chgData name="西浦　颯" userId="30eb12cf-a0f0-479c-babe-56a40fd49a1c" providerId="ADAL" clId="{CCF08334-B7FB-451B-84BC-3BE0F90B41AA}" dt="2024-05-14T09:27:19.510" v="220" actId="164"/>
          <ac:spMkLst>
            <pc:docMk/>
            <pc:sldMk cId="2570755398" sldId="264"/>
            <ac:spMk id="4" creationId="{27151215-241A-ED3C-5E52-92EB6295B77B}"/>
          </ac:spMkLst>
        </pc:spChg>
        <pc:spChg chg="add mod">
          <ac:chgData name="西浦　颯" userId="30eb12cf-a0f0-479c-babe-56a40fd49a1c" providerId="ADAL" clId="{CCF08334-B7FB-451B-84BC-3BE0F90B41AA}" dt="2024-05-14T09:27:19.510" v="220" actId="164"/>
          <ac:spMkLst>
            <pc:docMk/>
            <pc:sldMk cId="2570755398" sldId="264"/>
            <ac:spMk id="5" creationId="{7E5B4233-11EC-06A1-0AA0-7D25D6F8BC88}"/>
          </ac:spMkLst>
        </pc:spChg>
        <pc:spChg chg="add mod">
          <ac:chgData name="西浦　颯" userId="30eb12cf-a0f0-479c-babe-56a40fd49a1c" providerId="ADAL" clId="{CCF08334-B7FB-451B-84BC-3BE0F90B41AA}" dt="2024-05-14T09:27:19.510" v="220" actId="164"/>
          <ac:spMkLst>
            <pc:docMk/>
            <pc:sldMk cId="2570755398" sldId="264"/>
            <ac:spMk id="6" creationId="{2BBE01E4-64F8-2159-2144-3D968A759675}"/>
          </ac:spMkLst>
        </pc:spChg>
        <pc:spChg chg="add mod ord">
          <ac:chgData name="西浦　颯" userId="30eb12cf-a0f0-479c-babe-56a40fd49a1c" providerId="ADAL" clId="{CCF08334-B7FB-451B-84BC-3BE0F90B41AA}" dt="2024-05-14T09:27:19.510" v="220" actId="164"/>
          <ac:spMkLst>
            <pc:docMk/>
            <pc:sldMk cId="2570755398" sldId="264"/>
            <ac:spMk id="8" creationId="{EC45A65E-44A3-47C1-B51F-CE5B7F92090F}"/>
          </ac:spMkLst>
        </pc:spChg>
        <pc:spChg chg="mod">
          <ac:chgData name="西浦　颯" userId="30eb12cf-a0f0-479c-babe-56a40fd49a1c" providerId="ADAL" clId="{CCF08334-B7FB-451B-84BC-3BE0F90B41AA}" dt="2024-05-10T11:29:15.474" v="189" actId="164"/>
          <ac:spMkLst>
            <pc:docMk/>
            <pc:sldMk cId="2570755398" sldId="264"/>
            <ac:spMk id="34" creationId="{8DEF85F8-14D0-2811-4780-97453D2BEC38}"/>
          </ac:spMkLst>
        </pc:spChg>
        <pc:spChg chg="mod">
          <ac:chgData name="西浦　颯" userId="30eb12cf-a0f0-479c-babe-56a40fd49a1c" providerId="ADAL" clId="{CCF08334-B7FB-451B-84BC-3BE0F90B41AA}" dt="2024-05-10T11:29:15.474" v="189" actId="164"/>
          <ac:spMkLst>
            <pc:docMk/>
            <pc:sldMk cId="2570755398" sldId="264"/>
            <ac:spMk id="35" creationId="{B86EADD7-F21F-F233-3DF6-A9B48BA37F9B}"/>
          </ac:spMkLst>
        </pc:spChg>
        <pc:spChg chg="mod">
          <ac:chgData name="西浦　颯" userId="30eb12cf-a0f0-479c-babe-56a40fd49a1c" providerId="ADAL" clId="{CCF08334-B7FB-451B-84BC-3BE0F90B41AA}" dt="2024-05-10T11:29:15.474" v="189" actId="164"/>
          <ac:spMkLst>
            <pc:docMk/>
            <pc:sldMk cId="2570755398" sldId="264"/>
            <ac:spMk id="36" creationId="{55C1A466-0EC6-16D3-E046-E95F48D9D486}"/>
          </ac:spMkLst>
        </pc:spChg>
        <pc:spChg chg="mod">
          <ac:chgData name="西浦　颯" userId="30eb12cf-a0f0-479c-babe-56a40fd49a1c" providerId="ADAL" clId="{CCF08334-B7FB-451B-84BC-3BE0F90B41AA}" dt="2024-05-10T11:29:15.474" v="189" actId="164"/>
          <ac:spMkLst>
            <pc:docMk/>
            <pc:sldMk cId="2570755398" sldId="264"/>
            <ac:spMk id="37" creationId="{3A3E7CDA-9D62-DF67-0F22-D729AB1C2A99}"/>
          </ac:spMkLst>
        </pc:spChg>
        <pc:grpChg chg="add mod">
          <ac:chgData name="西浦　颯" userId="30eb12cf-a0f0-479c-babe-56a40fd49a1c" providerId="ADAL" clId="{CCF08334-B7FB-451B-84BC-3BE0F90B41AA}" dt="2024-05-14T09:27:19.510" v="220" actId="164"/>
          <ac:grpSpMkLst>
            <pc:docMk/>
            <pc:sldMk cId="2570755398" sldId="264"/>
            <ac:grpSpMk id="2" creationId="{141F44B2-489B-22A0-E59D-C9B1A14B080F}"/>
          </ac:grpSpMkLst>
        </pc:grpChg>
        <pc:grpChg chg="add mod">
          <ac:chgData name="西浦　颯" userId="30eb12cf-a0f0-479c-babe-56a40fd49a1c" providerId="ADAL" clId="{CCF08334-B7FB-451B-84BC-3BE0F90B41AA}" dt="2024-05-14T09:27:19.510" v="220" actId="164"/>
          <ac:grpSpMkLst>
            <pc:docMk/>
            <pc:sldMk cId="2570755398" sldId="264"/>
            <ac:grpSpMk id="10" creationId="{8570C53F-813B-76A2-C6AE-DF2669A3554D}"/>
          </ac:grpSpMkLst>
        </pc:grpChg>
        <pc:grpChg chg="mod">
          <ac:chgData name="西浦　颯" userId="30eb12cf-a0f0-479c-babe-56a40fd49a1c" providerId="ADAL" clId="{CCF08334-B7FB-451B-84BC-3BE0F90B41AA}" dt="2024-05-10T11:29:15.474" v="189" actId="164"/>
          <ac:grpSpMkLst>
            <pc:docMk/>
            <pc:sldMk cId="2570755398" sldId="264"/>
            <ac:grpSpMk id="49" creationId="{70F04356-A2ED-6281-7DED-CC1B9C066590}"/>
          </ac:grpSpMkLst>
        </pc:grpChg>
        <pc:grpChg chg="mod">
          <ac:chgData name="西浦　颯" userId="30eb12cf-a0f0-479c-babe-56a40fd49a1c" providerId="ADAL" clId="{CCF08334-B7FB-451B-84BC-3BE0F90B41AA}" dt="2024-05-10T11:29:15.474" v="189" actId="164"/>
          <ac:grpSpMkLst>
            <pc:docMk/>
            <pc:sldMk cId="2570755398" sldId="264"/>
            <ac:grpSpMk id="50" creationId="{7E36C0A1-6F82-E039-4108-4B8C9AF0A67A}"/>
          </ac:grpSpMkLst>
        </pc:grpChg>
        <pc:grpChg chg="mod">
          <ac:chgData name="西浦　颯" userId="30eb12cf-a0f0-479c-babe-56a40fd49a1c" providerId="ADAL" clId="{CCF08334-B7FB-451B-84BC-3BE0F90B41AA}" dt="2024-05-10T11:29:15.474" v="189" actId="164"/>
          <ac:grpSpMkLst>
            <pc:docMk/>
            <pc:sldMk cId="2570755398" sldId="264"/>
            <ac:grpSpMk id="51" creationId="{AE555551-EFFD-F289-E356-0F417D79F582}"/>
          </ac:grpSpMkLst>
        </pc:grpChg>
        <pc:grpChg chg="mod">
          <ac:chgData name="西浦　颯" userId="30eb12cf-a0f0-479c-babe-56a40fd49a1c" providerId="ADAL" clId="{CCF08334-B7FB-451B-84BC-3BE0F90B41AA}" dt="2024-05-10T11:29:15.474" v="189" actId="164"/>
          <ac:grpSpMkLst>
            <pc:docMk/>
            <pc:sldMk cId="2570755398" sldId="264"/>
            <ac:grpSpMk id="52" creationId="{8D83DEC3-30E9-480D-30A2-684A5394BA15}"/>
          </ac:grpSpMkLst>
        </pc:grpChg>
        <pc:picChg chg="mod modCrop">
          <ac:chgData name="西浦　颯" userId="30eb12cf-a0f0-479c-babe-56a40fd49a1c" providerId="ADAL" clId="{CCF08334-B7FB-451B-84BC-3BE0F90B41AA}" dt="2024-05-14T09:26:35.937" v="213" actId="732"/>
          <ac:picMkLst>
            <pc:docMk/>
            <pc:sldMk cId="2570755398" sldId="264"/>
            <ac:picMk id="17" creationId="{BBDB4489-76A9-78CD-B4CC-37A6A19A7472}"/>
          </ac:picMkLst>
        </pc:picChg>
        <pc:picChg chg="mod modCrop">
          <ac:chgData name="西浦　颯" userId="30eb12cf-a0f0-479c-babe-56a40fd49a1c" providerId="ADAL" clId="{CCF08334-B7FB-451B-84BC-3BE0F90B41AA}" dt="2024-05-14T09:26:32.165" v="212" actId="732"/>
          <ac:picMkLst>
            <pc:docMk/>
            <pc:sldMk cId="2570755398" sldId="264"/>
            <ac:picMk id="26" creationId="{5BB27CFE-0DA7-CE37-1F64-79466B15FB49}"/>
          </ac:picMkLst>
        </pc:picChg>
      </pc:sldChg>
      <pc:sldChg chg="addSp delSp modSp new del mod">
        <pc:chgData name="西浦　颯" userId="30eb12cf-a0f0-479c-babe-56a40fd49a1c" providerId="ADAL" clId="{CCF08334-B7FB-451B-84BC-3BE0F90B41AA}" dt="2024-05-10T08:43:33.064" v="177" actId="47"/>
        <pc:sldMkLst>
          <pc:docMk/>
          <pc:sldMk cId="824353450" sldId="265"/>
        </pc:sldMkLst>
        <pc:picChg chg="add del mod modCrop">
          <ac:chgData name="西浦　颯" userId="30eb12cf-a0f0-479c-babe-56a40fd49a1c" providerId="ADAL" clId="{CCF08334-B7FB-451B-84BC-3BE0F90B41AA}" dt="2024-05-10T02:50:58.365" v="25" actId="478"/>
          <ac:picMkLst>
            <pc:docMk/>
            <pc:sldMk cId="824353450" sldId="265"/>
            <ac:picMk id="3" creationId="{3679DB4E-FAE9-E266-B75F-0082C209BF40}"/>
          </ac:picMkLst>
        </pc:picChg>
      </pc:sldChg>
      <pc:sldChg chg="new del">
        <pc:chgData name="西浦　颯" userId="30eb12cf-a0f0-479c-babe-56a40fd49a1c" providerId="ADAL" clId="{CCF08334-B7FB-451B-84BC-3BE0F90B41AA}" dt="2024-05-10T02:50:12.204" v="17" actId="680"/>
        <pc:sldMkLst>
          <pc:docMk/>
          <pc:sldMk cId="3012457557" sldId="265"/>
        </pc:sldMkLst>
      </pc:sldChg>
    </pc:docChg>
  </pc:docChgLst>
  <pc:docChgLst>
    <pc:chgData name="西浦　颯" userId="30eb12cf-a0f0-479c-babe-56a40fd49a1c" providerId="ADAL" clId="{162AEC28-0285-49FB-A3CF-EDAC42BACC95}"/>
    <pc:docChg chg="undo custSel delSld modSld">
      <pc:chgData name="西浦　颯" userId="30eb12cf-a0f0-479c-babe-56a40fd49a1c" providerId="ADAL" clId="{162AEC28-0285-49FB-A3CF-EDAC42BACC95}" dt="2025-01-30T07:05:03.439" v="49" actId="1035"/>
      <pc:docMkLst>
        <pc:docMk/>
      </pc:docMkLst>
      <pc:sldChg chg="del">
        <pc:chgData name="西浦　颯" userId="30eb12cf-a0f0-479c-babe-56a40fd49a1c" providerId="ADAL" clId="{162AEC28-0285-49FB-A3CF-EDAC42BACC95}" dt="2025-01-30T06:45:43.893" v="0" actId="47"/>
        <pc:sldMkLst>
          <pc:docMk/>
          <pc:sldMk cId="3600378478" sldId="256"/>
        </pc:sldMkLst>
      </pc:sldChg>
      <pc:sldChg chg="del">
        <pc:chgData name="西浦　颯" userId="30eb12cf-a0f0-479c-babe-56a40fd49a1c" providerId="ADAL" clId="{162AEC28-0285-49FB-A3CF-EDAC42BACC95}" dt="2025-01-30T06:45:43.893" v="0" actId="47"/>
        <pc:sldMkLst>
          <pc:docMk/>
          <pc:sldMk cId="2775093129" sldId="257"/>
        </pc:sldMkLst>
      </pc:sldChg>
      <pc:sldChg chg="modSp mod">
        <pc:chgData name="西浦　颯" userId="30eb12cf-a0f0-479c-babe-56a40fd49a1c" providerId="ADAL" clId="{162AEC28-0285-49FB-A3CF-EDAC42BACC95}" dt="2025-01-30T07:05:03.439" v="49" actId="1035"/>
        <pc:sldMkLst>
          <pc:docMk/>
          <pc:sldMk cId="1552739713" sldId="261"/>
        </pc:sldMkLst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13" creationId="{3B220B2E-1DB8-BBB3-5ABD-B81F369ACD3E}"/>
          </ac:spMkLst>
        </pc:spChg>
        <pc:spChg chg="mod">
          <ac:chgData name="西浦　颯" userId="30eb12cf-a0f0-479c-babe-56a40fd49a1c" providerId="ADAL" clId="{162AEC28-0285-49FB-A3CF-EDAC42BACC95}" dt="2025-01-30T07:02:32.182" v="9" actId="14100"/>
          <ac:spMkLst>
            <pc:docMk/>
            <pc:sldMk cId="1552739713" sldId="261"/>
            <ac:spMk id="14" creationId="{B08E8C56-3F9D-4393-B23F-8B9C44B87713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15" creationId="{8BE1F01D-5651-4778-EEB5-BDD65FEF6C43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16" creationId="{4F2DEAFC-022A-B9FA-94A5-DB950B5E5B41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17" creationId="{490DE562-0F5C-4406-6BBF-5E49EDB541F8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18" creationId="{BF6AF18F-F389-9426-B82E-EE0ACA58B71C}"/>
          </ac:spMkLst>
        </pc:spChg>
        <pc:spChg chg="mod">
          <ac:chgData name="西浦　颯" userId="30eb12cf-a0f0-479c-babe-56a40fd49a1c" providerId="ADAL" clId="{162AEC28-0285-49FB-A3CF-EDAC42BACC95}" dt="2025-01-30T07:02:22.870" v="6" actId="14100"/>
          <ac:spMkLst>
            <pc:docMk/>
            <pc:sldMk cId="1552739713" sldId="261"/>
            <ac:spMk id="19" creationId="{353F3ADD-9883-7C60-62CB-0EE6E415AED3}"/>
          </ac:spMkLst>
        </pc:spChg>
        <pc:spChg chg="mod">
          <ac:chgData name="西浦　颯" userId="30eb12cf-a0f0-479c-babe-56a40fd49a1c" providerId="ADAL" clId="{162AEC28-0285-49FB-A3CF-EDAC42BACC95}" dt="2025-01-30T07:02:34.755" v="10" actId="14100"/>
          <ac:spMkLst>
            <pc:docMk/>
            <pc:sldMk cId="1552739713" sldId="261"/>
            <ac:spMk id="20" creationId="{9DC5AB7D-65A0-58C5-B05F-2449DAFC8CBD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1" creationId="{E6748492-F0C4-33AB-FD92-D8655D606160}"/>
          </ac:spMkLst>
        </pc:spChg>
        <pc:spChg chg="mod">
          <ac:chgData name="西浦　颯" userId="30eb12cf-a0f0-479c-babe-56a40fd49a1c" providerId="ADAL" clId="{162AEC28-0285-49FB-A3CF-EDAC42BACC95}" dt="2025-01-30T07:02:28.971" v="8" actId="14100"/>
          <ac:spMkLst>
            <pc:docMk/>
            <pc:sldMk cId="1552739713" sldId="261"/>
            <ac:spMk id="22" creationId="{E7FEF51F-2F6D-9A20-009B-B627EB51B003}"/>
          </ac:spMkLst>
        </pc:spChg>
        <pc:spChg chg="mod">
          <ac:chgData name="西浦　颯" userId="30eb12cf-a0f0-479c-babe-56a40fd49a1c" providerId="ADAL" clId="{162AEC28-0285-49FB-A3CF-EDAC42BACC95}" dt="2025-01-30T07:02:25.665" v="7" actId="14100"/>
          <ac:spMkLst>
            <pc:docMk/>
            <pc:sldMk cId="1552739713" sldId="261"/>
            <ac:spMk id="23" creationId="{82BE41C2-B16F-9BFE-4101-18A2F104D91A}"/>
          </ac:spMkLst>
        </pc:spChg>
        <pc:spChg chg="mod">
          <ac:chgData name="西浦　颯" userId="30eb12cf-a0f0-479c-babe-56a40fd49a1c" providerId="ADAL" clId="{162AEC28-0285-49FB-A3CF-EDAC42BACC95}" dt="2025-01-30T07:02:36.692" v="11" actId="14100"/>
          <ac:spMkLst>
            <pc:docMk/>
            <pc:sldMk cId="1552739713" sldId="261"/>
            <ac:spMk id="24" creationId="{297A7111-DAE6-D4F7-D343-D783C62B673B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5" creationId="{9AA670C2-9428-C00F-09F6-D9EF284B3717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6" creationId="{06C266A2-8F3A-8F72-2CC4-79E4FBBFA857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7" creationId="{E594BB18-F76A-A766-58B4-2446899F62D2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8" creationId="{1AAF0162-39BB-85A5-7633-2AC6DA0717B2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29" creationId="{C29DC909-417C-4067-CDBD-621FCE805DE5}"/>
          </ac:spMkLst>
        </pc:spChg>
        <pc:spChg chg="mod">
          <ac:chgData name="西浦　颯" userId="30eb12cf-a0f0-479c-babe-56a40fd49a1c" providerId="ADAL" clId="{162AEC28-0285-49FB-A3CF-EDAC42BACC95}" dt="2025-01-30T07:04:56.709" v="46" actId="1076"/>
          <ac:spMkLst>
            <pc:docMk/>
            <pc:sldMk cId="1552739713" sldId="261"/>
            <ac:spMk id="30" creationId="{09A0C8C0-5096-CB7C-2204-09841F85CE43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4" creationId="{7F437699-62CA-9AB6-17FD-A50DBEE953B3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5" creationId="{001A2B6A-129E-16AE-5165-ED09E6BC819B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6" creationId="{F5D8FCF7-A171-5121-1D00-C6906352BA9C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7" creationId="{04068F84-AA89-0429-2ED9-0AD43927A68C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8" creationId="{16E26396-81AC-FA0F-C7DE-395DE31ABBAD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39" creationId="{E2CE1392-6A27-15F4-CD28-35AE392F46BC}"/>
          </ac:spMkLst>
        </pc:spChg>
        <pc:spChg chg="mod">
          <ac:chgData name="西浦　颯" userId="30eb12cf-a0f0-479c-babe-56a40fd49a1c" providerId="ADAL" clId="{162AEC28-0285-49FB-A3CF-EDAC42BACC95}" dt="2025-01-30T07:02:19.402" v="5" actId="14100"/>
          <ac:spMkLst>
            <pc:docMk/>
            <pc:sldMk cId="1552739713" sldId="261"/>
            <ac:spMk id="40" creationId="{C10C29E9-48CE-FF43-5B2E-FA85F280AFE1}"/>
          </ac:spMkLst>
        </pc:spChg>
        <pc:spChg chg="mod">
          <ac:chgData name="西浦　颯" userId="30eb12cf-a0f0-479c-babe-56a40fd49a1c" providerId="ADAL" clId="{162AEC28-0285-49FB-A3CF-EDAC42BACC95}" dt="2025-01-30T07:02:15.501" v="4" actId="14100"/>
          <ac:spMkLst>
            <pc:docMk/>
            <pc:sldMk cId="1552739713" sldId="261"/>
            <ac:spMk id="41" creationId="{D483B6C4-79F5-6709-6FE0-81ECFF3636E7}"/>
          </ac:spMkLst>
        </pc:spChg>
        <pc:spChg chg="mod">
          <ac:chgData name="西浦　颯" userId="30eb12cf-a0f0-479c-babe-56a40fd49a1c" providerId="ADAL" clId="{162AEC28-0285-49FB-A3CF-EDAC42BACC95}" dt="2025-01-30T07:02:07.171" v="3" actId="403"/>
          <ac:spMkLst>
            <pc:docMk/>
            <pc:sldMk cId="1552739713" sldId="261"/>
            <ac:spMk id="42" creationId="{F0566FE3-22B5-6262-0E94-8DF37D76458A}"/>
          </ac:spMkLst>
        </pc:spChg>
        <pc:grpChg chg="mod">
          <ac:chgData name="西浦　颯" userId="30eb12cf-a0f0-479c-babe-56a40fd49a1c" providerId="ADAL" clId="{162AEC28-0285-49FB-A3CF-EDAC42BACC95}" dt="2025-01-30T07:05:03.439" v="49" actId="1035"/>
          <ac:grpSpMkLst>
            <pc:docMk/>
            <pc:sldMk cId="1552739713" sldId="261"/>
            <ac:grpSpMk id="43" creationId="{38C4F72A-6FCC-A9AC-641A-A6B25D388FF5}"/>
          </ac:grpSpMkLst>
        </pc:grpChg>
      </pc:sldChg>
      <pc:sldChg chg="del">
        <pc:chgData name="西浦　颯" userId="30eb12cf-a0f0-479c-babe-56a40fd49a1c" providerId="ADAL" clId="{162AEC28-0285-49FB-A3CF-EDAC42BACC95}" dt="2025-01-30T06:45:43.893" v="0" actId="47"/>
        <pc:sldMkLst>
          <pc:docMk/>
          <pc:sldMk cId="304154118" sldId="262"/>
        </pc:sldMkLst>
      </pc:sldChg>
      <pc:sldChg chg="del">
        <pc:chgData name="西浦　颯" userId="30eb12cf-a0f0-479c-babe-56a40fd49a1c" providerId="ADAL" clId="{162AEC28-0285-49FB-A3CF-EDAC42BACC95}" dt="2025-01-30T06:45:46.569" v="1" actId="47"/>
        <pc:sldMkLst>
          <pc:docMk/>
          <pc:sldMk cId="2987700762" sldId="263"/>
        </pc:sldMkLst>
      </pc:sldChg>
      <pc:sldChg chg="del">
        <pc:chgData name="西浦　颯" userId="30eb12cf-a0f0-479c-babe-56a40fd49a1c" providerId="ADAL" clId="{162AEC28-0285-49FB-A3CF-EDAC42BACC95}" dt="2025-01-30T06:45:46.569" v="1" actId="47"/>
        <pc:sldMkLst>
          <pc:docMk/>
          <pc:sldMk cId="2570755398" sldId="26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8AE867-2BBA-4C9B-936D-B22FC134CA28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5A2E3E-2FF1-4DC0-A814-C298F7CB39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680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9 Detailed structures from 185th to 200</a:t>
            </a:r>
            <a:r>
              <a:rPr kumimoji="1" lang="en-US" altLang="ja-JP" baseline="30000" dirty="0"/>
              <a:t>th</a:t>
            </a:r>
            <a:r>
              <a:rPr kumimoji="1" lang="en-US" altLang="ja-JP" dirty="0"/>
              <a:t> residues of four models; (a) Superpose of four models, (b)</a:t>
            </a:r>
            <a:r>
              <a:rPr kumimoji="1" lang="en-US" altLang="ja-JP" dirty="0" err="1"/>
              <a:t>Hiroshiima</a:t>
            </a:r>
            <a:r>
              <a:rPr kumimoji="1" lang="en-US" altLang="ja-JP" dirty="0"/>
              <a:t>/21A10C, (c) Kagoshima/21A1T, (d) Kagoshima/21A6T, and (d) Kagoshima/22A1T. Each color of the tube models corresponds to the drawing in </a:t>
            </a:r>
            <a:r>
              <a:rPr kumimoji="1" lang="en-US" altLang="ja-JP" b="1" dirty="0"/>
              <a:t>Figure M1</a:t>
            </a:r>
            <a:r>
              <a:rPr kumimoji="1" lang="en-US" altLang="ja-JP" dirty="0"/>
              <a:t>. Breaking lines indicate hydrogen bond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5A2E3E-2FF1-4DC0-A814-C298F7CB390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6522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9B8DB-50D2-FEE3-6F2A-467D9BD489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4D700C6-621B-37B2-2F31-2CF0963696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CC6CC4-EF80-0BB5-F0BE-2C179782E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7ADCAF-AA8B-B8EE-BE01-837956710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61BF8B-025C-B25E-CC49-E27345FFF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841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A36054-98A7-B5E1-CD04-8B51B67341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90E9B4-6D11-F383-1848-098B3FFF8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5192AF-B6C4-9745-4A1B-E01EB15FF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4717F5-537A-5686-4274-57CEEB9DB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87A6D7-6C8F-264D-1A57-EA2A91776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542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F454E86-94A6-2CAD-DF73-1613BEE3FA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ED60ED-B25D-1DE8-7F65-437E2D8D5E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06DBF9-3492-D0C1-FAB1-B41EE1212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DD52D7-7AF0-E0EC-BFF7-483EC439E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1A09F4-1384-97ED-4DA3-774495084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269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509196-C8C8-7DF2-2636-96B3CEFA4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1AC620C-292E-9418-D0A5-9E4788AB74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416261-71A7-782F-80B3-D35BCD4F5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B95326-1DD1-B9EF-86B6-6CA025076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905DCA-2BB3-0FAA-F20F-BD938A722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072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56D910-B693-F90A-A280-25629FDE7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5E12F44-E5AA-0163-AB1E-19A034E76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5FE59B-965E-557B-AECD-B07E8580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97067C-AF44-06DA-DB25-2C86A16D7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2232AF-FFBA-FF65-1FD8-5784226A5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2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EA2E95-0CE2-44B0-BB23-C1EAC2A9D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763AA97-4B2B-F01F-87D3-215E061E17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EA1C1E-8B37-4D10-4CDF-DA751F1911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FC9572-D8C0-13B9-BEF4-9E15A29DE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0274F3-38E9-590C-A09B-830FE7773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8C2D55-4177-041D-880B-60ACCD87B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775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AC2142-AF53-CFBF-2EA6-9E799928A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A0DDD02-6943-06CC-6EE0-29A93F8739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730940D-5D4B-8E8C-379D-6C277B601F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C143B89-8668-49C5-EAFF-669D157B51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2394256-8199-3A38-A556-2D25B7E45B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37511DC-BDEA-57BB-FDD5-8DE7CBB05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A193915-5007-73CC-4B72-677A71F9B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8E7715B-0DC2-1405-0CF7-966C8B6D8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562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55F337-2942-DDC7-6EA4-157898929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A685B33-1139-7A70-3080-299C13900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553F676-25E1-C2EA-9586-DA6D21113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13D0ED2-9746-ECF2-511A-93212E254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216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62D25BB-0AE1-F5FC-76DE-079D17B3A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5AB3FB0-67A2-4994-9778-F01F29335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7EB61BB-580C-0585-D332-D18EAB0EC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693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ED3BB4-AC1E-7B81-8596-6D11EFEA2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0211E7C-78C6-AD20-6BAB-99780EF2B8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DF5BD8-DD2F-0FD5-F554-6C14410001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896A03-F37F-3E19-AB6D-C3E9B3177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A330A8-6E22-B72D-E294-0C4998013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497A96-3314-5838-2381-4EEF75FE9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664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4C91E4-6968-A285-01F3-CA12C8DBE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789A75A-F652-33AB-4057-CB554EF03E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FB49ABB-A4FE-DFC2-FE4B-54D16331B2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4434879-2D14-2501-4470-2C00C0A36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62840A9-8B85-66A3-426E-D78B022D6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AF4FDF1-1133-BEBA-DC5C-0BE4B5126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6757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9B21E44-8AD9-F61A-03A9-7F87ED9F76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1CC0F4B-FCD6-6A29-6DC5-4BCC486CAC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5DB841-61DD-E41A-2280-D79B4D7960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806DA-666E-49CE-9BD1-DE3811E4C1E0}" type="datetimeFigureOut">
              <a:rPr kumimoji="1" lang="ja-JP" altLang="en-US" smtClean="0"/>
              <a:t>2025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AA9560-8E49-1AD2-642E-000DDEFFF1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15F941-2E47-670A-AE6E-BB8DD6C8C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F97A4-B2C3-4B4A-B820-A387521B3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247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38C4F72A-6FCC-A9AC-641A-A6B25D388FF5}"/>
              </a:ext>
            </a:extLst>
          </p:cNvPr>
          <p:cNvGrpSpPr/>
          <p:nvPr/>
        </p:nvGrpSpPr>
        <p:grpSpPr>
          <a:xfrm>
            <a:off x="0" y="-57150"/>
            <a:ext cx="12192000" cy="6858000"/>
            <a:chOff x="0" y="0"/>
            <a:chExt cx="12192000" cy="6858000"/>
          </a:xfrm>
        </p:grpSpPr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7F437699-62CA-9AB6-17FD-A50DBEE953B3}"/>
                </a:ext>
              </a:extLst>
            </p:cNvPr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B36D1D43-FA4D-BF59-7212-5E35540FD3D6}"/>
                </a:ext>
              </a:extLst>
            </p:cNvPr>
            <p:cNvGrpSpPr/>
            <p:nvPr/>
          </p:nvGrpSpPr>
          <p:grpSpPr>
            <a:xfrm>
              <a:off x="155905" y="295845"/>
              <a:ext cx="11760594" cy="6434777"/>
              <a:chOff x="155905" y="295845"/>
              <a:chExt cx="11760594" cy="6434777"/>
            </a:xfrm>
          </p:grpSpPr>
          <p:pic>
            <p:nvPicPr>
              <p:cNvPr id="10" name="図 9">
                <a:extLst>
                  <a:ext uri="{FF2B5EF4-FFF2-40B4-BE49-F238E27FC236}">
                    <a16:creationId xmlns:a16="http://schemas.microsoft.com/office/drawing/2014/main" id="{84A143FD-BA8F-63F8-FA68-B967187D6F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5905" y="677175"/>
                <a:ext cx="4598326" cy="4032077"/>
              </a:xfrm>
              <a:prstGeom prst="rect">
                <a:avLst/>
              </a:prstGeom>
            </p:spPr>
          </p:pic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9AA670C2-9428-C00F-09F6-D9EF284B3717}"/>
                  </a:ext>
                </a:extLst>
              </p:cNvPr>
              <p:cNvSpPr txBox="1"/>
              <p:nvPr/>
            </p:nvSpPr>
            <p:spPr>
              <a:xfrm>
                <a:off x="238974" y="341096"/>
                <a:ext cx="66331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kumimoji="1" lang="ja-JP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09A0C8C0-5096-CB7C-2204-09841F85CE43}"/>
                  </a:ext>
                </a:extLst>
              </p:cNvPr>
              <p:cNvSpPr txBox="1"/>
              <p:nvPr/>
            </p:nvSpPr>
            <p:spPr>
              <a:xfrm>
                <a:off x="186925" y="5160962"/>
                <a:ext cx="4807656" cy="1569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85            </a:t>
                </a:r>
                <a:r>
                  <a: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　　　　 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  <a:p>
                <a:r>
                  <a:rPr lang="en-US" altLang="ja-JP" sz="16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agoshima/22A1T      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NA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ja-JP" sz="16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KNPTT</a:t>
                </a:r>
                <a:endParaRPr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16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agoshima/21A1T      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NA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kumimoji="1" lang="en-US" altLang="ja-JP" sz="16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KNPTT</a:t>
                </a:r>
              </a:p>
              <a:p>
                <a:r>
                  <a:rPr kumimoji="1" lang="en-US" altLang="ja-JP" sz="16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agoshima/21A6T      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NA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kumimoji="1" lang="en-US" altLang="ja-JP" sz="16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kumimoji="1"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KNPTT</a:t>
                </a:r>
              </a:p>
              <a:p>
                <a:r>
                  <a:rPr lang="en-US" altLang="ja-JP" sz="16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roshima/21A10C  </a:t>
                </a:r>
                <a:r>
                  <a:rPr lang="en-US" altLang="ja-JP" sz="140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altLang="ja-JP" sz="14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NA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ja-JP" sz="16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ja-JP" sz="1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KNPTT</a:t>
                </a:r>
              </a:p>
              <a:p>
                <a:endPara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3DD204B0-9932-0364-D8DD-32B6F15424BB}"/>
                  </a:ext>
                </a:extLst>
              </p:cNvPr>
              <p:cNvGrpSpPr/>
              <p:nvPr/>
            </p:nvGrpSpPr>
            <p:grpSpPr>
              <a:xfrm>
                <a:off x="4795776" y="3527491"/>
                <a:ext cx="3527164" cy="3203131"/>
                <a:chOff x="4828740" y="3484747"/>
                <a:chExt cx="3527164" cy="3203131"/>
              </a:xfrm>
            </p:grpSpPr>
            <p:pic>
              <p:nvPicPr>
                <p:cNvPr id="7" name="図 6">
                  <a:extLst>
                    <a:ext uri="{FF2B5EF4-FFF2-40B4-BE49-F238E27FC236}">
                      <a16:creationId xmlns:a16="http://schemas.microsoft.com/office/drawing/2014/main" id="{4DB7AD4D-1C2E-5B24-FDA6-EECD9E0B58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862599" y="3494699"/>
                  <a:ext cx="3493305" cy="3084245"/>
                </a:xfrm>
                <a:prstGeom prst="rect">
                  <a:avLst/>
                </a:prstGeom>
              </p:spPr>
            </p:pic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8BE1F01D-5651-4778-EEB5-BDD65FEF6C43}"/>
                    </a:ext>
                  </a:extLst>
                </p:cNvPr>
                <p:cNvSpPr txBox="1"/>
                <p:nvPr/>
              </p:nvSpPr>
              <p:spPr>
                <a:xfrm>
                  <a:off x="5517790" y="6380101"/>
                  <a:ext cx="602316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5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353F3ADD-9883-7C60-62CB-0EE6E415AED3}"/>
                    </a:ext>
                  </a:extLst>
                </p:cNvPr>
                <p:cNvSpPr txBox="1"/>
                <p:nvPr/>
              </p:nvSpPr>
              <p:spPr>
                <a:xfrm>
                  <a:off x="5336113" y="3736786"/>
                  <a:ext cx="663314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9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82BE41C2-B16F-9BFE-4101-18A2F104D91A}"/>
                    </a:ext>
                  </a:extLst>
                </p:cNvPr>
                <p:cNvSpPr txBox="1"/>
                <p:nvPr/>
              </p:nvSpPr>
              <p:spPr>
                <a:xfrm>
                  <a:off x="7001598" y="3484747"/>
                  <a:ext cx="671757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D193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1AAF0162-39BB-85A5-7633-2AC6DA0717B2}"/>
                    </a:ext>
                  </a:extLst>
                </p:cNvPr>
                <p:cNvSpPr txBox="1"/>
                <p:nvPr/>
              </p:nvSpPr>
              <p:spPr>
                <a:xfrm>
                  <a:off x="4828740" y="3541960"/>
                  <a:ext cx="66331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d)</a:t>
                  </a:r>
                  <a:endParaRPr kumimoji="1" lang="ja-JP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001A2B6A-129E-16AE-5165-ED09E6BC819B}"/>
                    </a:ext>
                  </a:extLst>
                </p:cNvPr>
                <p:cNvSpPr txBox="1"/>
                <p:nvPr/>
              </p:nvSpPr>
              <p:spPr>
                <a:xfrm>
                  <a:off x="6585690" y="5810839"/>
                  <a:ext cx="812800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400" b="1" u="sng" dirty="0">
                      <a:solidFill>
                        <a:srgbClr val="7030A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Q191</a:t>
                  </a:r>
                  <a:endParaRPr lang="ja-JP" altLang="en-US" sz="1400" b="1" u="sng" dirty="0">
                    <a:solidFill>
                      <a:srgbClr val="7030A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699C885B-82D9-64AC-93DA-6DC0034C8FDC}"/>
                  </a:ext>
                </a:extLst>
              </p:cNvPr>
              <p:cNvGrpSpPr/>
              <p:nvPr/>
            </p:nvGrpSpPr>
            <p:grpSpPr>
              <a:xfrm>
                <a:off x="4802183" y="344581"/>
                <a:ext cx="3511313" cy="3172805"/>
                <a:chOff x="8284246" y="3541960"/>
                <a:chExt cx="3511313" cy="3172805"/>
              </a:xfrm>
            </p:grpSpPr>
            <p:pic>
              <p:nvPicPr>
                <p:cNvPr id="9" name="図 8">
                  <a:extLst>
                    <a:ext uri="{FF2B5EF4-FFF2-40B4-BE49-F238E27FC236}">
                      <a16:creationId xmlns:a16="http://schemas.microsoft.com/office/drawing/2014/main" id="{9E6A3733-A9D1-7401-17EF-DE900F2577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342074" y="3587080"/>
                  <a:ext cx="3453485" cy="3127685"/>
                </a:xfrm>
                <a:prstGeom prst="rect">
                  <a:avLst/>
                </a:prstGeom>
              </p:spPr>
            </p:pic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3B220B2E-1DB8-BBB3-5ABD-B81F369ACD3E}"/>
                    </a:ext>
                  </a:extLst>
                </p:cNvPr>
                <p:cNvSpPr txBox="1"/>
                <p:nvPr/>
              </p:nvSpPr>
              <p:spPr>
                <a:xfrm>
                  <a:off x="8976057" y="6380102"/>
                  <a:ext cx="614572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S185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490DE562-0F5C-4406-6BBF-5E49EDB541F8}"/>
                    </a:ext>
                  </a:extLst>
                </p:cNvPr>
                <p:cNvSpPr txBox="1"/>
                <p:nvPr/>
              </p:nvSpPr>
              <p:spPr>
                <a:xfrm>
                  <a:off x="8823370" y="3906712"/>
                  <a:ext cx="614573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9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E6748492-F0C4-33AB-FD92-D8655D606160}"/>
                    </a:ext>
                  </a:extLst>
                </p:cNvPr>
                <p:cNvSpPr txBox="1"/>
                <p:nvPr/>
              </p:nvSpPr>
              <p:spPr>
                <a:xfrm>
                  <a:off x="10164516" y="3775242"/>
                  <a:ext cx="616296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A193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C29DC909-417C-4067-CDBD-621FCE805DE5}"/>
                    </a:ext>
                  </a:extLst>
                </p:cNvPr>
                <p:cNvSpPr txBox="1"/>
                <p:nvPr/>
              </p:nvSpPr>
              <p:spPr>
                <a:xfrm>
                  <a:off x="8284246" y="3541960"/>
                  <a:ext cx="66331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b)</a:t>
                  </a:r>
                  <a:endParaRPr kumimoji="1" lang="ja-JP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F5D8FCF7-A171-5121-1D00-C6906352BA9C}"/>
                    </a:ext>
                  </a:extLst>
                </p:cNvPr>
                <p:cNvSpPr txBox="1"/>
                <p:nvPr/>
              </p:nvSpPr>
              <p:spPr>
                <a:xfrm>
                  <a:off x="10008969" y="5878572"/>
                  <a:ext cx="812800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400" b="1" u="sng" dirty="0">
                      <a:solidFill>
                        <a:srgbClr val="7030A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Q191</a:t>
                  </a:r>
                  <a:endParaRPr lang="ja-JP" altLang="en-US" sz="1400" b="1" u="sng" dirty="0">
                    <a:solidFill>
                      <a:srgbClr val="7030A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C40AC4E9-0AA3-DECD-7D71-4655EDDDB484}"/>
                  </a:ext>
                </a:extLst>
              </p:cNvPr>
              <p:cNvGrpSpPr/>
              <p:nvPr/>
            </p:nvGrpSpPr>
            <p:grpSpPr>
              <a:xfrm>
                <a:off x="8360436" y="3481027"/>
                <a:ext cx="3556063" cy="3204896"/>
                <a:chOff x="4828740" y="189183"/>
                <a:chExt cx="3556063" cy="3204896"/>
              </a:xfrm>
            </p:grpSpPr>
            <p:pic>
              <p:nvPicPr>
                <p:cNvPr id="3" name="図 2">
                  <a:extLst>
                    <a:ext uri="{FF2B5EF4-FFF2-40B4-BE49-F238E27FC236}">
                      <a16:creationId xmlns:a16="http://schemas.microsoft.com/office/drawing/2014/main" id="{99841E0C-AE42-6A2E-51B1-567D489447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4837198" y="295041"/>
                  <a:ext cx="3547605" cy="3098724"/>
                </a:xfrm>
                <a:prstGeom prst="rect">
                  <a:avLst/>
                </a:prstGeom>
              </p:spPr>
            </p:pic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4F2DEAFC-022A-B9FA-94A5-DB950B5E5B41}"/>
                    </a:ext>
                  </a:extLst>
                </p:cNvPr>
                <p:cNvSpPr txBox="1"/>
                <p:nvPr/>
              </p:nvSpPr>
              <p:spPr>
                <a:xfrm>
                  <a:off x="5543605" y="3086302"/>
                  <a:ext cx="602316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5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9DC5AB7D-65A0-58C5-B05F-2449DAFC8CBD}"/>
                    </a:ext>
                  </a:extLst>
                </p:cNvPr>
                <p:cNvSpPr txBox="1"/>
                <p:nvPr/>
              </p:nvSpPr>
              <p:spPr>
                <a:xfrm>
                  <a:off x="5529550" y="325941"/>
                  <a:ext cx="624258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K189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297A7111-DAE6-D4F7-D343-D783C62B673B}"/>
                    </a:ext>
                  </a:extLst>
                </p:cNvPr>
                <p:cNvSpPr txBox="1"/>
                <p:nvPr/>
              </p:nvSpPr>
              <p:spPr>
                <a:xfrm>
                  <a:off x="6992090" y="189183"/>
                  <a:ext cx="663314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93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06C266A2-8F3A-8F72-2CC4-79E4FBBFA857}"/>
                    </a:ext>
                  </a:extLst>
                </p:cNvPr>
                <p:cNvSpPr txBox="1"/>
                <p:nvPr/>
              </p:nvSpPr>
              <p:spPr>
                <a:xfrm>
                  <a:off x="4828740" y="189183"/>
                  <a:ext cx="66331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e)</a:t>
                  </a:r>
                  <a:endParaRPr kumimoji="1" lang="ja-JP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04068F84-AA89-0429-2ED9-0AD43927A68C}"/>
                    </a:ext>
                  </a:extLst>
                </p:cNvPr>
                <p:cNvSpPr txBox="1"/>
                <p:nvPr/>
              </p:nvSpPr>
              <p:spPr>
                <a:xfrm>
                  <a:off x="6613151" y="2593020"/>
                  <a:ext cx="812800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400" b="1" u="sng" dirty="0">
                      <a:solidFill>
                        <a:srgbClr val="7030A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Q191</a:t>
                  </a:r>
                  <a:endParaRPr lang="ja-JP" altLang="en-US" sz="1400" b="1" u="sng" dirty="0">
                    <a:solidFill>
                      <a:srgbClr val="7030A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CA9B823E-BD3C-E18B-ADE3-931B9E5286CE}"/>
                  </a:ext>
                </a:extLst>
              </p:cNvPr>
              <p:cNvGrpSpPr/>
              <p:nvPr/>
            </p:nvGrpSpPr>
            <p:grpSpPr>
              <a:xfrm>
                <a:off x="8322940" y="295845"/>
                <a:ext cx="3531664" cy="3228759"/>
                <a:chOff x="8284246" y="189183"/>
                <a:chExt cx="3531664" cy="3228759"/>
              </a:xfrm>
            </p:grpSpPr>
            <p:pic>
              <p:nvPicPr>
                <p:cNvPr id="5" name="図 4">
                  <a:extLst>
                    <a:ext uri="{FF2B5EF4-FFF2-40B4-BE49-F238E27FC236}">
                      <a16:creationId xmlns:a16="http://schemas.microsoft.com/office/drawing/2014/main" id="{4ABFB457-6168-CB07-1D49-A48D440C86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8358805" y="337378"/>
                  <a:ext cx="3457105" cy="3033564"/>
                </a:xfrm>
                <a:prstGeom prst="rect">
                  <a:avLst/>
                </a:prstGeom>
              </p:spPr>
            </p:pic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B08E8C56-3F9D-4393-B23F-8B9C44B87713}"/>
                    </a:ext>
                  </a:extLst>
                </p:cNvPr>
                <p:cNvSpPr txBox="1"/>
                <p:nvPr/>
              </p:nvSpPr>
              <p:spPr>
                <a:xfrm>
                  <a:off x="8985057" y="3110165"/>
                  <a:ext cx="605572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5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BF6AF18F-F389-9426-B82E-EE0ACA58B71C}"/>
                    </a:ext>
                  </a:extLst>
                </p:cNvPr>
                <p:cNvSpPr txBox="1"/>
                <p:nvPr/>
              </p:nvSpPr>
              <p:spPr>
                <a:xfrm>
                  <a:off x="8745399" y="422466"/>
                  <a:ext cx="658914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189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E7FEF51F-2F6D-9A20-009B-B627EB51B003}"/>
                    </a:ext>
                  </a:extLst>
                </p:cNvPr>
                <p:cNvSpPr txBox="1"/>
                <p:nvPr/>
              </p:nvSpPr>
              <p:spPr>
                <a:xfrm>
                  <a:off x="10068816" y="407648"/>
                  <a:ext cx="612015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u="sng" dirty="0">
                      <a:solidFill>
                        <a:srgbClr val="C0000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D193</a:t>
                  </a:r>
                  <a:endParaRPr kumimoji="1" lang="ja-JP" altLang="en-US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E594BB18-F76A-A766-58B4-2446899F62D2}"/>
                    </a:ext>
                  </a:extLst>
                </p:cNvPr>
                <p:cNvSpPr txBox="1"/>
                <p:nvPr/>
              </p:nvSpPr>
              <p:spPr>
                <a:xfrm>
                  <a:off x="8284246" y="189183"/>
                  <a:ext cx="66331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c)</a:t>
                  </a:r>
                  <a:endParaRPr kumimoji="1" lang="ja-JP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16E26396-81AC-FA0F-C7DE-395DE31ABBAD}"/>
                    </a:ext>
                  </a:extLst>
                </p:cNvPr>
                <p:cNvSpPr txBox="1"/>
                <p:nvPr/>
              </p:nvSpPr>
              <p:spPr>
                <a:xfrm>
                  <a:off x="10068816" y="2593020"/>
                  <a:ext cx="812800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400" b="1" u="sng" dirty="0">
                      <a:solidFill>
                        <a:srgbClr val="7030A0"/>
                      </a:solidFill>
                      <a:highlight>
                        <a:srgbClr val="FFFF00"/>
                      </a:highlight>
                      <a:latin typeface="Arial" panose="020B0604020202020204" pitchFamily="34" charset="0"/>
                      <a:cs typeface="Arial" panose="020B0604020202020204" pitchFamily="34" charset="0"/>
                    </a:rPr>
                    <a:t>Q191</a:t>
                  </a:r>
                  <a:endParaRPr lang="ja-JP" altLang="en-US" sz="1400" b="1" u="sng" dirty="0">
                    <a:solidFill>
                      <a:srgbClr val="7030A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E2CE1392-6A27-15F4-CD28-35AE392F46BC}"/>
                  </a:ext>
                </a:extLst>
              </p:cNvPr>
              <p:cNvSpPr txBox="1"/>
              <p:nvPr/>
            </p:nvSpPr>
            <p:spPr>
              <a:xfrm>
                <a:off x="2521893" y="3754824"/>
                <a:ext cx="81280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400" b="1" u="sng" dirty="0">
                    <a:solidFill>
                      <a:srgbClr val="7030A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Q191</a:t>
                </a:r>
                <a:endParaRPr lang="ja-JP" altLang="en-US" sz="1400" b="1" u="sng" dirty="0">
                  <a:solidFill>
                    <a:srgbClr val="7030A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C10C29E9-48CE-FF43-5B2E-FA85F280AFE1}"/>
                  </a:ext>
                </a:extLst>
              </p:cNvPr>
              <p:cNvSpPr txBox="1"/>
              <p:nvPr/>
            </p:nvSpPr>
            <p:spPr>
              <a:xfrm>
                <a:off x="813268" y="4451984"/>
                <a:ext cx="843693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S/P</a:t>
                </a:r>
                <a:r>
                  <a:rPr kumimoji="1" lang="en-US" altLang="ja-JP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185</a:t>
                </a:r>
                <a:endParaRPr kumimoji="1" lang="ja-JP" altLang="en-US" sz="1400" b="1" u="sng" dirty="0">
                  <a:solidFill>
                    <a:srgbClr val="C0000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D483B6C4-79F5-6709-6FE0-81ECFF3636E7}"/>
                  </a:ext>
                </a:extLst>
              </p:cNvPr>
              <p:cNvSpPr txBox="1"/>
              <p:nvPr/>
            </p:nvSpPr>
            <p:spPr>
              <a:xfrm>
                <a:off x="911733" y="660330"/>
                <a:ext cx="843694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K/E189</a:t>
                </a:r>
                <a:endParaRPr kumimoji="1" lang="ja-JP" altLang="en-US" sz="1400" b="1" u="sng" dirty="0">
                  <a:solidFill>
                    <a:srgbClr val="C0000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F0566FE3-22B5-6262-0E94-8DF37D76458A}"/>
                  </a:ext>
                </a:extLst>
              </p:cNvPr>
              <p:cNvSpPr txBox="1"/>
              <p:nvPr/>
            </p:nvSpPr>
            <p:spPr>
              <a:xfrm>
                <a:off x="2805162" y="538675"/>
                <a:ext cx="812800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/A</a:t>
                </a:r>
                <a:r>
                  <a:rPr kumimoji="1" lang="en-US" altLang="ja-JP" sz="1400" b="1" u="sng" dirty="0">
                    <a:solidFill>
                      <a:srgbClr val="C00000"/>
                    </a:solidFill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193</a:t>
                </a:r>
                <a:endParaRPr kumimoji="1" lang="ja-JP" altLang="en-US" sz="1400" b="1" u="sng" dirty="0">
                  <a:solidFill>
                    <a:srgbClr val="C0000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52739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1</TotalTime>
  <Words>131</Words>
  <Application>Microsoft Office PowerPoint</Application>
  <PresentationFormat>ワイド画面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前田　美紀</dc:creator>
  <cp:lastModifiedBy>Hayate Nishiura</cp:lastModifiedBy>
  <cp:revision>34</cp:revision>
  <dcterms:created xsi:type="dcterms:W3CDTF">2024-04-26T05:43:04Z</dcterms:created>
  <dcterms:modified xsi:type="dcterms:W3CDTF">2025-01-30T07:05:05Z</dcterms:modified>
</cp:coreProperties>
</file>